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26"/>
  </p:normalViewPr>
  <p:slideViewPr>
    <p:cSldViewPr snapToGrid="0">
      <p:cViewPr varScale="1">
        <p:scale>
          <a:sx n="105" d="100"/>
          <a:sy n="105" d="100"/>
        </p:scale>
        <p:origin x="8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B8DE86-CA5C-E468-F9CB-2B8D9797E9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76963F-BB43-4FD2-96EF-B2F4B6ABB2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D2219-04EF-0F12-C66C-22DC99947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493F40-70A8-8BB1-B630-ED335809D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B9304C-85CD-3300-F1C1-A963A9A72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90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573C10-14E5-258B-D8F2-0C6232BFF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797FBD-5032-519C-BE35-5BAB191E41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1471E-4396-27F0-5DB3-8C619E43C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84D47-C456-8AE0-BAEC-E1CFD4FBE5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DC9869-05AF-77AA-AD4F-6F4B86985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977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381D73-6520-9E5B-AEEC-773ED5A089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D6A722-6500-76E5-2FB7-95C8AFC6D8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F4D2B5-FEA8-EBBA-9657-96336FDB1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DEB6F9-0E63-E108-CF53-44610E2BE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704A0-7BA3-88C3-88C3-D7D7DCB97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42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248D1-7537-2548-F2EB-D9109D363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178575-F950-D1E9-F9ED-25FA441AA1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1502E8-112A-8FDB-F57A-6A6C0BC4A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C36749-AE8F-D208-A4BE-1D1264AAF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D3E8B-446E-D3CC-CDD9-524D1D32C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533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FF7E1-0178-774A-D0AF-E5732EBE8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91FA12-597C-D9D0-B3DC-A781E5A87A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0C9FB-5BB7-4F4C-C322-A7D4BF219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B95468-EEB0-232B-B168-5B2541CDC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743E10-50BE-5A28-B8DA-3219BC82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964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007561-A533-5DAF-1105-602FFB118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98E395-E911-67D2-3611-E55C0FE4BC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0B87B5-407D-7E60-E97D-C08623848F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4ABE0E-502E-AE6C-4CFE-E573885E9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87C557-3ECD-3D2D-E10C-0FF233E98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6457A8-887A-C63E-03AC-BBEC1B114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165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6A8A9-13E5-3290-E248-A1A709800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6A19E3-4FFF-59E3-A7F9-F86A6EC72F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FDBB42-5882-B405-F8C2-2A9214B17C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4F13AD-3B29-2ACF-0D8F-493ADBCF8F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23DB70-AA58-3BA5-C191-DAACB9A385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59BAE5-915F-F3D2-3710-A7D579C3F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DD5563-8D25-F122-4462-AC7784025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D194E1-56A6-16A7-92CD-4B7363850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60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C6C84-6455-1716-698E-99FB17CD9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91D0EA-C7DA-7333-E2C8-CF573BF2F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ED7796-320D-A7A4-64F6-C82142949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D39AAB-EACA-F94C-A17A-2FD3FE7D8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203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3FF031-977F-17DE-FBD5-B351F9CA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6F552C-EC15-BB8A-727D-A092304FA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9BE521-D51E-D8A8-56C5-06C3673B3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90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FDBB42-3819-59E7-545C-E14386923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AC4C37-269D-0C16-1F7D-90FD2ABEE4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4059B-7E16-9796-66C9-872B08D097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5A3D7E-6A5C-5B86-81DB-E02F52027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46735E-177E-B945-4741-3C41A9230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0098E4-FDB1-80F8-9618-CCB54C293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601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76FD6-C0E9-9F7F-905D-7B45D58E0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BE07FD-62BB-9C51-6230-D2104C8CE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58DC74-88CC-44B9-EAEE-930374A3FF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0D9F6A-2FF3-DE2A-5BC2-8EB32450A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05F955-3228-E48E-A4E6-3AAB2FB5A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FA3A68-D84E-A703-BD9C-91E7468E8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68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59382E-13FD-8AE9-8ED1-6FA6E36DE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122310-4425-69E0-83EC-F56864D581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E9E6AA-5D88-A891-0E10-52E68FE832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6C3B5-6CC3-2A4B-9C8F-9DF851AE2635}" type="datetimeFigureOut">
              <a:rPr lang="en-US" smtClean="0"/>
              <a:t>7/2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5DD4A5-5EAB-E6FC-240B-1B524D6682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AD412E-0D69-C6D8-07B4-4ED3789153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5FF15-C1F3-124C-822E-3B2F33E12C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155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FBD06BBF-83ED-C39C-F2FF-0E31788AB9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6565" y="488253"/>
            <a:ext cx="10258869" cy="588149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0B5A304-2B6C-1334-FDE1-787F664D6D64}"/>
              </a:ext>
            </a:extLst>
          </p:cNvPr>
          <p:cNvSpPr txBox="1"/>
          <p:nvPr/>
        </p:nvSpPr>
        <p:spPr>
          <a:xfrm>
            <a:off x="7729728" y="24384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antibody (ng/mL)</a:t>
            </a:r>
          </a:p>
        </p:txBody>
      </p:sp>
    </p:spTree>
    <p:extLst>
      <p:ext uri="{BB962C8B-B14F-4D97-AF65-F5344CB8AC3E}">
        <p14:creationId xmlns:p14="http://schemas.microsoft.com/office/powerpoint/2010/main" val="9607643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B45A6ED-4454-A7E5-D7A4-B8C5FD8AC2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1822" y="738251"/>
            <a:ext cx="10696194" cy="50904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E4B863F-62ED-BB75-CE11-45E3450578C9}"/>
              </a:ext>
            </a:extLst>
          </p:cNvPr>
          <p:cNvSpPr txBox="1"/>
          <p:nvPr/>
        </p:nvSpPr>
        <p:spPr>
          <a:xfrm>
            <a:off x="7729728" y="243840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36733804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9C06345-1C57-0FEB-9B4F-F6198B35FA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4378" y="609601"/>
            <a:ext cx="9896428" cy="56876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CDDE8DC-63FF-A733-D632-062E5F5BAE6A}"/>
              </a:ext>
            </a:extLst>
          </p:cNvPr>
          <p:cNvSpPr txBox="1"/>
          <p:nvPr/>
        </p:nvSpPr>
        <p:spPr>
          <a:xfrm>
            <a:off x="7729728" y="243840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11394073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718F479-468D-7A5E-AD7C-33929A37F9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4623" y="546343"/>
            <a:ext cx="9842754" cy="576531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778434-ADED-5E30-B8F2-14E441943FD7}"/>
              </a:ext>
            </a:extLst>
          </p:cNvPr>
          <p:cNvSpPr txBox="1"/>
          <p:nvPr/>
        </p:nvSpPr>
        <p:spPr>
          <a:xfrm>
            <a:off x="7729728" y="243840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23998381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05D747F-9B52-534E-027D-57941EC3AF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698" y="705231"/>
            <a:ext cx="10364604" cy="544753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E572AB0-4581-F29E-5DC7-A0C1F5BEBE2C}"/>
              </a:ext>
            </a:extLst>
          </p:cNvPr>
          <p:cNvSpPr txBox="1"/>
          <p:nvPr/>
        </p:nvSpPr>
        <p:spPr>
          <a:xfrm>
            <a:off x="7729728" y="243840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317930516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98198A7-CCE2-98FE-82D3-ECA39A2854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4872" y="533400"/>
            <a:ext cx="9922256" cy="57912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4FF5AD-70A1-1A15-BC16-F5E08FE050E0}"/>
              </a:ext>
            </a:extLst>
          </p:cNvPr>
          <p:cNvSpPr txBox="1"/>
          <p:nvPr/>
        </p:nvSpPr>
        <p:spPr>
          <a:xfrm>
            <a:off x="7729728" y="243840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40693381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44DA23C-30A4-E8CA-7A00-DA48B326D7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848" y="797657"/>
            <a:ext cx="10814304" cy="52626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106AA94-F180-3B9F-AAE7-A61978763997}"/>
              </a:ext>
            </a:extLst>
          </p:cNvPr>
          <p:cNvSpPr txBox="1"/>
          <p:nvPr/>
        </p:nvSpPr>
        <p:spPr>
          <a:xfrm>
            <a:off x="7729728" y="243840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3230084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71CFE65-299C-9F1C-095A-17D3B0F7B0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5088" y="524402"/>
            <a:ext cx="10190543" cy="59069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E3A3C83-1148-0C69-FB21-AA0C0463D953}"/>
              </a:ext>
            </a:extLst>
          </p:cNvPr>
          <p:cNvSpPr txBox="1"/>
          <p:nvPr/>
        </p:nvSpPr>
        <p:spPr>
          <a:xfrm>
            <a:off x="7729728" y="24384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antibody (ng/mL)</a:t>
            </a:r>
          </a:p>
        </p:txBody>
      </p:sp>
    </p:spTree>
    <p:extLst>
      <p:ext uri="{BB962C8B-B14F-4D97-AF65-F5344CB8AC3E}">
        <p14:creationId xmlns:p14="http://schemas.microsoft.com/office/powerpoint/2010/main" val="35456133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D82A696-FFAB-10CA-5F6A-357540CEE9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500" y="599821"/>
            <a:ext cx="10511256" cy="56583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69938F-BECF-1CD4-3BF3-2EE31A7DB496}"/>
              </a:ext>
            </a:extLst>
          </p:cNvPr>
          <p:cNvSpPr txBox="1"/>
          <p:nvPr/>
        </p:nvSpPr>
        <p:spPr>
          <a:xfrm>
            <a:off x="7729728" y="24384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antibody (ng/mL)</a:t>
            </a:r>
          </a:p>
        </p:txBody>
      </p:sp>
    </p:spTree>
    <p:extLst>
      <p:ext uri="{BB962C8B-B14F-4D97-AF65-F5344CB8AC3E}">
        <p14:creationId xmlns:p14="http://schemas.microsoft.com/office/powerpoint/2010/main" val="1681310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0628E1E-28E5-E743-3208-C8B4B14BBD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504" y="598574"/>
            <a:ext cx="9714992" cy="56608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2472160-26A2-1013-3FBA-A46F7E912A8F}"/>
              </a:ext>
            </a:extLst>
          </p:cNvPr>
          <p:cNvSpPr txBox="1"/>
          <p:nvPr/>
        </p:nvSpPr>
        <p:spPr>
          <a:xfrm>
            <a:off x="7729728" y="24384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antibody (ng/mL)</a:t>
            </a:r>
          </a:p>
        </p:txBody>
      </p:sp>
    </p:spTree>
    <p:extLst>
      <p:ext uri="{BB962C8B-B14F-4D97-AF65-F5344CB8AC3E}">
        <p14:creationId xmlns:p14="http://schemas.microsoft.com/office/powerpoint/2010/main" val="29903541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13C580E-61C8-FD6A-73C4-A23BD8476F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194" y="774319"/>
            <a:ext cx="10782826" cy="507784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059801D-FA8C-6BDB-9463-AD78F5311EAC}"/>
              </a:ext>
            </a:extLst>
          </p:cNvPr>
          <p:cNvSpPr txBox="1"/>
          <p:nvPr/>
        </p:nvSpPr>
        <p:spPr>
          <a:xfrm>
            <a:off x="7729728" y="24384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tal antibody (ng/mL)</a:t>
            </a:r>
          </a:p>
        </p:txBody>
      </p:sp>
    </p:spTree>
    <p:extLst>
      <p:ext uri="{BB962C8B-B14F-4D97-AF65-F5344CB8AC3E}">
        <p14:creationId xmlns:p14="http://schemas.microsoft.com/office/powerpoint/2010/main" val="34461451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F666F0-2DC1-203F-0B86-52148B7770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4404" y="625538"/>
            <a:ext cx="10263191" cy="560692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A13BA6C-CA59-B937-203B-858E349E608F}"/>
              </a:ext>
            </a:extLst>
          </p:cNvPr>
          <p:cNvSpPr txBox="1"/>
          <p:nvPr/>
        </p:nvSpPr>
        <p:spPr>
          <a:xfrm>
            <a:off x="7729728" y="243840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29913550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11BE791-12CC-6F23-5D21-BD8E00D879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2670" y="630349"/>
            <a:ext cx="9832594" cy="55973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1B6391C-AE40-D1A4-E4F8-B1203FEFA701}"/>
              </a:ext>
            </a:extLst>
          </p:cNvPr>
          <p:cNvSpPr txBox="1"/>
          <p:nvPr/>
        </p:nvSpPr>
        <p:spPr>
          <a:xfrm>
            <a:off x="7729728" y="243840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10609766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B73B03B-3EBE-33F9-92AA-553FFB80EF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8053" y="713232"/>
            <a:ext cx="10075893" cy="54315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0C82BFC-0336-7F72-25BC-8F15FCD18787}"/>
              </a:ext>
            </a:extLst>
          </p:cNvPr>
          <p:cNvSpPr txBox="1"/>
          <p:nvPr/>
        </p:nvSpPr>
        <p:spPr>
          <a:xfrm>
            <a:off x="7729728" y="243840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41284157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CC2EDC-64EA-A16F-D2A5-77021D2FD2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2499" y="721360"/>
            <a:ext cx="9907002" cy="56062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FACA3D7-EF15-BC60-EB7C-0FF35B3B9C12}"/>
              </a:ext>
            </a:extLst>
          </p:cNvPr>
          <p:cNvSpPr txBox="1"/>
          <p:nvPr/>
        </p:nvSpPr>
        <p:spPr>
          <a:xfrm>
            <a:off x="7729728" y="243840"/>
            <a:ext cx="3082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jugate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BDm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g/mL)</a:t>
            </a:r>
          </a:p>
        </p:txBody>
      </p:sp>
    </p:spTree>
    <p:extLst>
      <p:ext uri="{BB962C8B-B14F-4D97-AF65-F5344CB8AC3E}">
        <p14:creationId xmlns:p14="http://schemas.microsoft.com/office/powerpoint/2010/main" val="2056350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05</Words>
  <Application>Microsoft Macintosh PowerPoint</Application>
  <PresentationFormat>Widescreen</PresentationFormat>
  <Paragraphs>15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il Lewis</dc:creator>
  <cp:lastModifiedBy>Gail Lewis</cp:lastModifiedBy>
  <cp:revision>2</cp:revision>
  <dcterms:created xsi:type="dcterms:W3CDTF">2023-07-25T17:44:38Z</dcterms:created>
  <dcterms:modified xsi:type="dcterms:W3CDTF">2023-07-25T19:24:40Z</dcterms:modified>
</cp:coreProperties>
</file>